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  <p:sldId id="259" r:id="rId3"/>
  </p:sldIdLst>
  <p:sldSz cx="9144000" cy="6858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10" userDrawn="1">
          <p15:clr>
            <a:srgbClr val="A4A3A4"/>
          </p15:clr>
        </p15:guide>
        <p15:guide id="2" pos="34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324" autoAdjust="0"/>
    <p:restoredTop sz="94660"/>
  </p:normalViewPr>
  <p:slideViewPr>
    <p:cSldViewPr snapToGrid="0" showGuides="1">
      <p:cViewPr varScale="1">
        <p:scale>
          <a:sx n="121" d="100"/>
          <a:sy n="121" d="100"/>
        </p:scale>
        <p:origin x="1824" y="96"/>
      </p:cViewPr>
      <p:guideLst>
        <p:guide orient="horz" pos="4110"/>
        <p:guide pos="34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3ABA8-7CFC-46F3-9860-DDAD465D5A59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13262-D0C2-491C-A1BE-87861E144A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5608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3ABA8-7CFC-46F3-9860-DDAD465D5A59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13262-D0C2-491C-A1BE-87861E144A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0580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3ABA8-7CFC-46F3-9860-DDAD465D5A59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13262-D0C2-491C-A1BE-87861E144A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32008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3ABA8-7CFC-46F3-9860-DDAD465D5A59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13262-D0C2-491C-A1BE-87861E144A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71740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3ABA8-7CFC-46F3-9860-DDAD465D5A59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13262-D0C2-491C-A1BE-87861E144A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4398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3ABA8-7CFC-46F3-9860-DDAD465D5A59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13262-D0C2-491C-A1BE-87861E144A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42794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3ABA8-7CFC-46F3-9860-DDAD465D5A59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13262-D0C2-491C-A1BE-87861E144A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0275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3ABA8-7CFC-46F3-9860-DDAD465D5A59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13262-D0C2-491C-A1BE-87861E144A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5347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3ABA8-7CFC-46F3-9860-DDAD465D5A59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13262-D0C2-491C-A1BE-87861E144A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80573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3ABA8-7CFC-46F3-9860-DDAD465D5A59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13262-D0C2-491C-A1BE-87861E144A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9172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3ABA8-7CFC-46F3-9860-DDAD465D5A59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13262-D0C2-491C-A1BE-87861E144A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5785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C3ABA8-7CFC-46F3-9860-DDAD465D5A59}" type="datetimeFigureOut">
              <a:rPr lang="fr-FR" smtClean="0"/>
              <a:t>20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F13262-D0C2-491C-A1BE-87861E144A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5463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7947141"/>
              </p:ext>
            </p:extLst>
          </p:nvPr>
        </p:nvGraphicFramePr>
        <p:xfrm>
          <a:off x="1728511" y="1231759"/>
          <a:ext cx="5943148" cy="45909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9" r:id="rId3" imgW="9112514" imgH="7041011" progId="Prism9.Document">
                  <p:embed/>
                </p:oleObj>
              </mc:Choice>
              <mc:Fallback>
                <p:oleObj name="Prism 9" r:id="rId3" imgW="9112514" imgH="7041011" progId="Prism9.Document">
                  <p:embed/>
                  <p:pic>
                    <p:nvPicPr>
                      <p:cNvPr id="2" name="Obje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28511" y="1231759"/>
                        <a:ext cx="5943148" cy="45909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ZoneTexte 2"/>
          <p:cNvSpPr txBox="1"/>
          <p:nvPr/>
        </p:nvSpPr>
        <p:spPr>
          <a:xfrm>
            <a:off x="261194" y="971865"/>
            <a:ext cx="78252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350" dirty="0" smtClean="0"/>
              <a:t>A) Saliva</a:t>
            </a:r>
            <a:endParaRPr lang="fr-FR" sz="1350" dirty="0"/>
          </a:p>
        </p:txBody>
      </p:sp>
      <p:sp>
        <p:nvSpPr>
          <p:cNvPr id="5" name="Rectangle 4"/>
          <p:cNvSpPr/>
          <p:nvPr/>
        </p:nvSpPr>
        <p:spPr>
          <a:xfrm>
            <a:off x="55180" y="115998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Supplementary Figure 2</a:t>
            </a:r>
            <a:r>
              <a:rPr lang="en-US" sz="1200" dirty="0"/>
              <a:t>: Boxplots showing distribution of sensitivity score of the subjects according to their high (N = 50) or low (N = 50) abundance in the species correlated significantly with several tastes in A) saliva and B) lingual film. The number of stars (*: p &lt; 0.05 ; **p &lt; 0.01; ***p &lt; 0.001; ns: non significant) indicates the significance level of the Wilcoxon test depicting difference between the two groups.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5697450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15624873"/>
              </p:ext>
            </p:extLst>
          </p:nvPr>
        </p:nvGraphicFramePr>
        <p:xfrm>
          <a:off x="1464856" y="675946"/>
          <a:ext cx="7094561" cy="54786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4" name="Prism 9" r:id="rId3" imgW="9115395" imgH="7039211" progId="Prism9.Document">
                  <p:embed/>
                </p:oleObj>
              </mc:Choice>
              <mc:Fallback>
                <p:oleObj name="Prism 9" r:id="rId3" imgW="9115395" imgH="7039211" progId="Prism9.Document">
                  <p:embed/>
                  <p:pic>
                    <p:nvPicPr>
                      <p:cNvPr id="2" name="Obje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64856" y="675946"/>
                        <a:ext cx="7094561" cy="54786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ZoneTexte 2"/>
          <p:cNvSpPr txBox="1"/>
          <p:nvPr/>
        </p:nvSpPr>
        <p:spPr>
          <a:xfrm>
            <a:off x="163223" y="851770"/>
            <a:ext cx="120738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350" dirty="0" smtClean="0"/>
              <a:t>B) Lingual Film</a:t>
            </a:r>
            <a:endParaRPr lang="fr-FR" sz="1350" dirty="0"/>
          </a:p>
        </p:txBody>
      </p:sp>
    </p:spTree>
    <p:extLst>
      <p:ext uri="{BB962C8B-B14F-4D97-AF65-F5344CB8AC3E}">
        <p14:creationId xmlns:p14="http://schemas.microsoft.com/office/powerpoint/2010/main" val="3489678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</TotalTime>
  <Words>94</Words>
  <Application>Microsoft Office PowerPoint</Application>
  <PresentationFormat>Affichage à l'écran (4:3)</PresentationFormat>
  <Paragraphs>3</Paragraphs>
  <Slides>2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rism 9</vt:lpstr>
      <vt:lpstr>Présentation PowerPoint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ric Neyraud</dc:creator>
  <cp:lastModifiedBy>Eric Neyraud</cp:lastModifiedBy>
  <cp:revision>15</cp:revision>
  <dcterms:created xsi:type="dcterms:W3CDTF">2022-05-05T13:56:01Z</dcterms:created>
  <dcterms:modified xsi:type="dcterms:W3CDTF">2023-06-20T08:00:34Z</dcterms:modified>
</cp:coreProperties>
</file>